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5DD6B4-9E6D-45B8-BB95-E3106B2B2EC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F50982-1DFD-4AEF-8061-C98A6237799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3FC010-9376-43FF-9489-E8219485C23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588723-E76F-4122-931B-21EFEF59050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0364A9-7334-421C-B286-BCC34ED2D52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34F075-CC6E-4465-B33C-133FFF226A1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8422B1-20ED-4A9F-8BA3-5DA7CF7CF6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890554-0DBB-4AE4-9CE9-971FEA9F957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6CC9CD-B170-4562-83D4-E90CD824938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4B179B-08AC-47CD-9EAC-E027383F41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A8FC92-3CF9-4FA7-B44F-92DD7343F0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DEADAA-3435-40D8-ACD0-78CBF3A734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6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6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6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C6C50E3-0684-4B56-9568-923C6012942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24 Grupo"/>
          <p:cNvGrpSpPr/>
          <p:nvPr/>
        </p:nvGrpSpPr>
        <p:grpSpPr>
          <a:xfrm>
            <a:off x="1495440" y="1187280"/>
            <a:ext cx="3962520" cy="3915000"/>
            <a:chOff x="1495440" y="1187280"/>
            <a:chExt cx="3962520" cy="3915000"/>
          </a:xfrm>
        </p:grpSpPr>
        <p:pic>
          <p:nvPicPr>
            <p:cNvPr id="42" name="Picture 6" descr="ok"/>
            <p:cNvPicPr/>
            <p:nvPr/>
          </p:nvPicPr>
          <p:blipFill>
            <a:blip r:embed="rId1"/>
            <a:srcRect l="0" t="55620" r="0" b="0"/>
            <a:stretch/>
          </p:blipFill>
          <p:spPr>
            <a:xfrm>
              <a:off x="1630080" y="1223640"/>
              <a:ext cx="3737160" cy="1325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Line 7"/>
            <p:cNvSpPr/>
            <p:nvPr/>
          </p:nvSpPr>
          <p:spPr>
            <a:xfrm>
              <a:off x="3498840" y="2295000"/>
              <a:ext cx="72720" cy="0"/>
            </a:xfrm>
            <a:prstGeom prst="line">
              <a:avLst/>
            </a:prstGeom>
            <a:ln w="9360">
              <a:solidFill>
                <a:srgbClr val="ffff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Line 8"/>
            <p:cNvSpPr/>
            <p:nvPr/>
          </p:nvSpPr>
          <p:spPr>
            <a:xfrm>
              <a:off x="2581200" y="2014200"/>
              <a:ext cx="72720" cy="0"/>
            </a:xfrm>
            <a:prstGeom prst="line">
              <a:avLst/>
            </a:prstGeom>
            <a:ln w="9360">
              <a:solidFill>
                <a:srgbClr val="ffff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Line 9"/>
            <p:cNvSpPr/>
            <p:nvPr/>
          </p:nvSpPr>
          <p:spPr>
            <a:xfrm>
              <a:off x="1645920" y="2225160"/>
              <a:ext cx="72720" cy="0"/>
            </a:xfrm>
            <a:prstGeom prst="line">
              <a:avLst/>
            </a:prstGeom>
            <a:ln w="9360">
              <a:solidFill>
                <a:srgbClr val="ffff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Line 10"/>
            <p:cNvSpPr/>
            <p:nvPr/>
          </p:nvSpPr>
          <p:spPr>
            <a:xfrm>
              <a:off x="1746000" y="2225160"/>
              <a:ext cx="3486240" cy="0"/>
            </a:xfrm>
            <a:prstGeom prst="line">
              <a:avLst/>
            </a:prstGeom>
            <a:ln w="9360">
              <a:solidFill>
                <a:srgbClr val="ffff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Line 11"/>
            <p:cNvSpPr/>
            <p:nvPr/>
          </p:nvSpPr>
          <p:spPr>
            <a:xfrm flipH="1">
              <a:off x="5251680" y="2225160"/>
              <a:ext cx="71280" cy="0"/>
            </a:xfrm>
            <a:prstGeom prst="line">
              <a:avLst/>
            </a:prstGeom>
            <a:ln w="9360">
              <a:solidFill>
                <a:srgbClr val="ffff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12"/>
            <p:cNvSpPr/>
            <p:nvPr/>
          </p:nvSpPr>
          <p:spPr>
            <a:xfrm>
              <a:off x="1562040" y="1187280"/>
              <a:ext cx="323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95400"/>
                  <a:tab algn="l" pos="1990800"/>
                  <a:tab algn="l" pos="2986200"/>
                  <a:tab algn="l" pos="3981600"/>
                  <a:tab algn="l" pos="4976640"/>
                  <a:tab algn="l" pos="5972040"/>
                  <a:tab algn="l" pos="6967440"/>
                  <a:tab algn="l" pos="7962840"/>
                  <a:tab algn="l" pos="8958240"/>
                  <a:tab algn="l" pos="9953640"/>
                  <a:tab algn="l" pos="10949040"/>
                </a:tabLst>
              </a:pPr>
              <a:r>
                <a:rPr b="0" lang="es-ES_tradnl" sz="1200" spc="-1" strike="noStrike">
                  <a:solidFill>
                    <a:srgbClr val="ffffff"/>
                  </a:solidFill>
                  <a:latin typeface="Arial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13"/>
            <p:cNvSpPr/>
            <p:nvPr/>
          </p:nvSpPr>
          <p:spPr>
            <a:xfrm>
              <a:off x="2506680" y="1187280"/>
              <a:ext cx="323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95400"/>
                  <a:tab algn="l" pos="1990800"/>
                  <a:tab algn="l" pos="2986200"/>
                  <a:tab algn="l" pos="3981600"/>
                  <a:tab algn="l" pos="4976640"/>
                  <a:tab algn="l" pos="5972040"/>
                  <a:tab algn="l" pos="6967440"/>
                  <a:tab algn="l" pos="7962840"/>
                  <a:tab algn="l" pos="8958240"/>
                  <a:tab algn="l" pos="9953640"/>
                  <a:tab algn="l" pos="10949040"/>
                </a:tabLst>
              </a:pPr>
              <a:r>
                <a:rPr b="0" lang="es-ES_tradnl" sz="1200" spc="-1" strike="noStrike">
                  <a:solidFill>
                    <a:srgbClr val="ffffff"/>
                  </a:solidFill>
                  <a:latin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14"/>
            <p:cNvSpPr/>
            <p:nvPr/>
          </p:nvSpPr>
          <p:spPr>
            <a:xfrm>
              <a:off x="3451320" y="1187280"/>
              <a:ext cx="323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95400"/>
                  <a:tab algn="l" pos="1990800"/>
                  <a:tab algn="l" pos="2986200"/>
                  <a:tab algn="l" pos="3981600"/>
                  <a:tab algn="l" pos="4976640"/>
                  <a:tab algn="l" pos="5972040"/>
                  <a:tab algn="l" pos="6967440"/>
                  <a:tab algn="l" pos="7962840"/>
                  <a:tab algn="l" pos="8958240"/>
                  <a:tab algn="l" pos="9953640"/>
                  <a:tab algn="l" pos="10949040"/>
                </a:tabLst>
              </a:pPr>
              <a:r>
                <a:rPr b="0" lang="es-ES_tradnl" sz="1200" spc="-1" strike="noStrike">
                  <a:solidFill>
                    <a:srgbClr val="ffffff"/>
                  </a:solidFill>
                  <a:latin typeface="Arial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15"/>
            <p:cNvSpPr/>
            <p:nvPr/>
          </p:nvSpPr>
          <p:spPr>
            <a:xfrm>
              <a:off x="4419720" y="1187280"/>
              <a:ext cx="323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95400"/>
                  <a:tab algn="l" pos="1990800"/>
                  <a:tab algn="l" pos="2986200"/>
                  <a:tab algn="l" pos="3981600"/>
                  <a:tab algn="l" pos="4976640"/>
                  <a:tab algn="l" pos="5972040"/>
                  <a:tab algn="l" pos="6967440"/>
                  <a:tab algn="l" pos="7962840"/>
                  <a:tab algn="l" pos="8958240"/>
                  <a:tab algn="l" pos="9953640"/>
                  <a:tab algn="l" pos="10949040"/>
                </a:tabLst>
              </a:pPr>
              <a:r>
                <a:rPr b="0" lang="es-ES_tradnl" sz="1200" spc="-1" strike="noStrike">
                  <a:solidFill>
                    <a:srgbClr val="ffffff"/>
                  </a:solidFill>
                  <a:latin typeface="Arial"/>
                </a:rPr>
                <a:t>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2" name="Picture 31" descr="fpcp-RNAi-09"/>
            <p:cNvPicPr/>
            <p:nvPr/>
          </p:nvPicPr>
          <p:blipFill>
            <a:blip r:embed="rId2">
              <a:lum contrast="6000"/>
            </a:blip>
            <a:srcRect l="0" t="0" r="0" b="3657"/>
            <a:stretch/>
          </p:blipFill>
          <p:spPr>
            <a:xfrm>
              <a:off x="4454640" y="2577600"/>
              <a:ext cx="912600" cy="1082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Picture 18" descr="fpcp-WT-vd-03"/>
            <p:cNvPicPr/>
            <p:nvPr/>
          </p:nvPicPr>
          <p:blipFill>
            <a:blip r:embed="rId3"/>
            <a:srcRect l="0" t="0" r="0" b="3772"/>
            <a:stretch/>
          </p:blipFill>
          <p:spPr>
            <a:xfrm>
              <a:off x="1630080" y="2577600"/>
              <a:ext cx="912600" cy="1083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Picture 19" descr="fpcp-04"/>
            <p:cNvPicPr/>
            <p:nvPr/>
          </p:nvPicPr>
          <p:blipFill>
            <a:blip r:embed="rId4"/>
            <a:srcRect l="0" t="0" r="0" b="3657"/>
            <a:stretch/>
          </p:blipFill>
          <p:spPr>
            <a:xfrm>
              <a:off x="2571840" y="2577600"/>
              <a:ext cx="912600" cy="1082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5" name="Picture 20" descr="fpcp-RNAi-pt-02"/>
            <p:cNvPicPr/>
            <p:nvPr/>
          </p:nvPicPr>
          <p:blipFill>
            <a:blip r:embed="rId5"/>
            <a:srcRect l="0" t="0" r="0" b="3529"/>
            <a:stretch/>
          </p:blipFill>
          <p:spPr>
            <a:xfrm>
              <a:off x="3513240" y="2577600"/>
              <a:ext cx="912600" cy="1083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6" name="Text Box 21"/>
            <p:cNvSpPr/>
            <p:nvPr/>
          </p:nvSpPr>
          <p:spPr>
            <a:xfrm>
              <a:off x="1553400" y="2539440"/>
              <a:ext cx="282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1200" spc="-1" strike="noStrike">
                  <a:solidFill>
                    <a:srgbClr val="ffffff"/>
                  </a:solidFill>
                  <a:latin typeface="Arial"/>
                </a:rPr>
                <a:t>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22"/>
            <p:cNvSpPr/>
            <p:nvPr/>
          </p:nvSpPr>
          <p:spPr>
            <a:xfrm>
              <a:off x="2498760" y="2539440"/>
              <a:ext cx="27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1200" spc="-1" strike="noStrike">
                  <a:solidFill>
                    <a:srgbClr val="ffffff"/>
                  </a:solidFill>
                  <a:latin typeface="Arial"/>
                </a:rPr>
                <a:t>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 Box 23"/>
            <p:cNvSpPr/>
            <p:nvPr/>
          </p:nvSpPr>
          <p:spPr>
            <a:xfrm>
              <a:off x="3446640" y="2539440"/>
              <a:ext cx="299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1200" spc="-1" strike="noStrike">
                  <a:solidFill>
                    <a:srgbClr val="ffffff"/>
                  </a:solidFill>
                  <a:latin typeface="Arial"/>
                </a:rPr>
                <a:t>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24"/>
            <p:cNvSpPr/>
            <p:nvPr/>
          </p:nvSpPr>
          <p:spPr>
            <a:xfrm>
              <a:off x="4383000" y="253944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1200" spc="-1" strike="noStrike">
                  <a:solidFill>
                    <a:srgbClr val="ffffff"/>
                  </a:solidFill>
                  <a:latin typeface="Arial"/>
                </a:rPr>
                <a:t>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25"/>
            <p:cNvSpPr/>
            <p:nvPr/>
          </p:nvSpPr>
          <p:spPr>
            <a:xfrm>
              <a:off x="1714320" y="3325320"/>
              <a:ext cx="0" cy="30312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36"/>
            <p:cNvSpPr/>
            <p:nvPr/>
          </p:nvSpPr>
          <p:spPr>
            <a:xfrm>
              <a:off x="2654280" y="3326760"/>
              <a:ext cx="0" cy="30312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37"/>
            <p:cNvSpPr/>
            <p:nvPr/>
          </p:nvSpPr>
          <p:spPr>
            <a:xfrm>
              <a:off x="3600360" y="3325320"/>
              <a:ext cx="0" cy="30312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38"/>
            <p:cNvSpPr/>
            <p:nvPr/>
          </p:nvSpPr>
          <p:spPr>
            <a:xfrm>
              <a:off x="4540320" y="3325320"/>
              <a:ext cx="0" cy="30312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50"/>
            <p:cNvSpPr/>
            <p:nvPr/>
          </p:nvSpPr>
          <p:spPr>
            <a:xfrm>
              <a:off x="1495440" y="3730680"/>
              <a:ext cx="3962520" cy="1371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95400"/>
                  <a:tab algn="l" pos="1990800"/>
                  <a:tab algn="l" pos="2986200"/>
                  <a:tab algn="l" pos="3981600"/>
                  <a:tab algn="l" pos="4976640"/>
                  <a:tab algn="l" pos="5972040"/>
                  <a:tab algn="l" pos="6967440"/>
                  <a:tab algn="l" pos="7962840"/>
                  <a:tab algn="l" pos="8958240"/>
                  <a:tab algn="l" pos="9953640"/>
                  <a:tab algn="l" pos="1094904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</a:rPr>
                <a:t>Figure S2. Altered cell wall properties of </a:t>
              </a:r>
              <a:r>
                <a:rPr b="1" i="1" lang="en-GB" sz="1200" spc="-1" strike="noStrike">
                  <a:solidFill>
                    <a:srgbClr val="000000"/>
                  </a:solidFill>
                  <a:latin typeface="Times New Roman"/>
                </a:rPr>
                <a:t>TAGL1</a:t>
              </a: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</a:rPr>
                <a:t> silenced fruits.</a:t>
              </a: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</a:rPr>
                <a:t> Cell wall swelling</a:t>
              </a:r>
              <a:r>
                <a:rPr b="0" i="1" lang="en-GB" sz="1200" spc="-1" strike="noStrike">
                  <a:solidFill>
                    <a:srgbClr val="000000"/>
                  </a:solidFill>
                  <a:latin typeface="Times New Roman"/>
                </a:rPr>
                <a:t> in vitro</a:t>
              </a: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</a:rPr>
                <a:t> from mature green (A, C) and red ripe (B, D) fruits from WT (A, B) and </a:t>
              </a:r>
              <a:r>
                <a:rPr b="0" i="1" lang="en-GB" sz="1200" spc="-1" strike="noStrike">
                  <a:solidFill>
                    <a:srgbClr val="000000"/>
                  </a:solidFill>
                  <a:latin typeface="Times New Roman"/>
                </a:rPr>
                <a:t>TAGL1 </a:t>
              </a: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</a:rPr>
                <a:t>RNAi (C, D) plants. </a:t>
              </a: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racture planes </a:t>
              </a: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</a:rPr>
                <a:t>of mature  green (E, G) and ripe red pericarps (F, H)</a:t>
              </a:r>
              <a:r>
                <a:rPr b="0" lang="en-GB" sz="1200" spc="-1" strike="noStrike">
                  <a:solidFill>
                    <a:srgbClr val="ff0000"/>
                  </a:solidFill>
                  <a:latin typeface="Times New Roman"/>
                </a:rPr>
                <a:t> </a:t>
              </a: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</a:rPr>
                <a:t>from WT (E, F) and </a:t>
              </a:r>
              <a:r>
                <a:rPr b="0" i="1" lang="en-GB" sz="1200" spc="-1" strike="noStrike">
                  <a:solidFill>
                    <a:srgbClr val="000000"/>
                  </a:solidFill>
                  <a:latin typeface="Times New Roman"/>
                </a:rPr>
                <a:t>TAGL1 </a:t>
              </a: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</a:rPr>
                <a:t>RNAi</a:t>
              </a:r>
              <a:r>
                <a:rPr b="0" i="1" lang="en-GB" sz="12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</a:rPr>
                <a:t>(G, H) plants were ex</a:t>
              </a: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mined by scanning electron microscopy</a:t>
              </a: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</a:rPr>
                <a:t>. Bars: 500 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µm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14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28T19:34:00Z</dcterms:created>
  <dc:creator>Estela</dc:creator>
  <dc:description/>
  <dc:language>en-US</dc:language>
  <cp:lastModifiedBy>Rafael Lozano</cp:lastModifiedBy>
  <dcterms:modified xsi:type="dcterms:W3CDTF">2010-11-17T14:55:17Z</dcterms:modified>
  <cp:revision>79</cp:revision>
  <dc:subject/>
  <dc:title>Diapositiva 1</dc:title>
</cp:coreProperties>
</file>